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72" r:id="rId3"/>
    <p:sldId id="259" r:id="rId4"/>
    <p:sldId id="277" r:id="rId5"/>
    <p:sldId id="260" r:id="rId6"/>
    <p:sldId id="261" r:id="rId7"/>
    <p:sldId id="262" r:id="rId8"/>
    <p:sldId id="263" r:id="rId9"/>
    <p:sldId id="273" r:id="rId10"/>
    <p:sldId id="264" r:id="rId11"/>
    <p:sldId id="265" r:id="rId12"/>
    <p:sldId id="266" r:id="rId13"/>
    <p:sldId id="267" r:id="rId14"/>
    <p:sldId id="268" r:id="rId15"/>
    <p:sldId id="274" r:id="rId16"/>
    <p:sldId id="269" r:id="rId17"/>
    <p:sldId id="275" r:id="rId18"/>
    <p:sldId id="270" r:id="rId19"/>
    <p:sldId id="271" r:id="rId20"/>
    <p:sldId id="276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8768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077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4269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53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0659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88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212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40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907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990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903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BC448C-7959-42AE-AEB1-F01EC5FF029B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AF44E-8732-43B9-B628-8D0173B3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098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91247"/>
            <a:ext cx="10515600" cy="523149"/>
          </a:xfrm>
        </p:spPr>
        <p:txBody>
          <a:bodyPr>
            <a:normAutofit/>
          </a:bodyPr>
          <a:lstStyle/>
          <a:p>
            <a:r>
              <a:rPr lang="de-DE" sz="2500" b="1" dirty="0">
                <a:latin typeface="+mn-lt"/>
              </a:rPr>
              <a:t>Contents</a:t>
            </a:r>
            <a:endParaRPr lang="en-GB" sz="2500" b="1" dirty="0">
              <a:latin typeface="+mn-lt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200" y="1080000"/>
            <a:ext cx="10515600" cy="512322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600" b="1" dirty="0"/>
              <a:t>Microarray / full training set / ANN</a:t>
            </a:r>
          </a:p>
          <a:p>
            <a:pPr marL="0" indent="0">
              <a:buNone/>
            </a:pPr>
            <a:r>
              <a:rPr lang="en-GB" sz="1600" dirty="0"/>
              <a:t>Figure S1: Figure with confidence intervals for accuracy and Brier score for microarray experiment comparing the ANN classification performances of the different augmentation methods after 1-fold augmentation. </a:t>
            </a:r>
          </a:p>
          <a:p>
            <a:pPr marL="0" indent="0">
              <a:buNone/>
            </a:pPr>
            <a:r>
              <a:rPr lang="en-GB" sz="1600" dirty="0"/>
              <a:t>Figure S2: Figure with confidence intervals for accuracy and Brier score for microarray experiment comparing the ANN classification performances of the different augmentation methods after 2-fold augmentation. </a:t>
            </a:r>
          </a:p>
          <a:p>
            <a:pPr marL="0" indent="0">
              <a:buNone/>
            </a:pPr>
            <a:r>
              <a:rPr lang="en-GB" sz="1600" dirty="0"/>
              <a:t>Figure S3: Figure with confidence intervals for accuracy and Brier score for microarray experiment comparing the ANN classification performances of the different augmentation methods after 3-fold augmentation. </a:t>
            </a:r>
          </a:p>
          <a:p>
            <a:pPr marL="0" indent="0">
              <a:buNone/>
            </a:pPr>
            <a:r>
              <a:rPr lang="en-GB" sz="1600" dirty="0"/>
              <a:t>Figure S4: Figure with confidence intervals for accuracy and Brier score for microarray experiment comparing the ANN classification performances of the different augmentation methods after 5-fold augmentation. </a:t>
            </a:r>
          </a:p>
          <a:p>
            <a:pPr marL="0" indent="0">
              <a:buNone/>
            </a:pPr>
            <a:r>
              <a:rPr lang="en-GB" sz="1600" dirty="0"/>
              <a:t>Figure S</a:t>
            </a:r>
            <a:r>
              <a:rPr lang="de-DE" sz="1600" dirty="0"/>
              <a:t>5: </a:t>
            </a:r>
            <a:r>
              <a:rPr lang="en-GB" sz="1600" dirty="0"/>
              <a:t>Figure with confidence intervals for F1 score for microarray experiment comparing the ANN classification performances of the different augmentation methods after 5-fold augmentation.</a:t>
            </a:r>
          </a:p>
          <a:p>
            <a:pPr marL="0" indent="0">
              <a:buNone/>
            </a:pP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41510900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6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1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48830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7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2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17156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8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3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290187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9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550254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0: Figure with confidence intervals for F1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 </a:t>
            </a:r>
            <a:r>
              <a:rPr lang="en-GB" sz="2000" dirty="0"/>
              <a:t>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. 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969881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1: Figure with confidence intervals for accuracy and Brier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2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2681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2: Figure with confidence intervals for accuracy and Brier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0353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3: Figure with confidence intervals for F1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847332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4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2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57967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5: Figure with confidence intervals for accuracy and Brier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7097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91247"/>
            <a:ext cx="10515600" cy="523149"/>
          </a:xfrm>
        </p:spPr>
        <p:txBody>
          <a:bodyPr>
            <a:normAutofit/>
          </a:bodyPr>
          <a:lstStyle/>
          <a:p>
            <a:r>
              <a:rPr lang="de-DE" sz="2500" b="1" dirty="0">
                <a:latin typeface="+mn-lt"/>
              </a:rPr>
              <a:t>Contents</a:t>
            </a:r>
            <a:endParaRPr lang="en-GB" sz="2500" b="1" dirty="0">
              <a:latin typeface="+mn-lt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200" y="1080000"/>
            <a:ext cx="10515600" cy="512322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600" b="1" dirty="0"/>
              <a:t>RNA-</a:t>
            </a:r>
            <a:r>
              <a:rPr lang="en-GB" sz="1600" b="1" dirty="0" err="1"/>
              <a:t>Seq</a:t>
            </a:r>
            <a:r>
              <a:rPr lang="en-GB" sz="1600" b="1" dirty="0"/>
              <a:t> / full training set / ANN</a:t>
            </a:r>
          </a:p>
          <a:p>
            <a:pPr marL="0" indent="0">
              <a:buNone/>
            </a:pPr>
            <a:r>
              <a:rPr lang="en-GB" sz="1600" dirty="0"/>
              <a:t>Figure S6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1-fold augmentation. </a:t>
            </a:r>
          </a:p>
          <a:p>
            <a:pPr marL="0" indent="0">
              <a:buNone/>
            </a:pPr>
            <a:r>
              <a:rPr lang="en-GB" sz="1600" dirty="0"/>
              <a:t>Figure S7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2-fold augmentation. </a:t>
            </a:r>
          </a:p>
          <a:p>
            <a:pPr marL="0" indent="0">
              <a:buNone/>
            </a:pPr>
            <a:r>
              <a:rPr lang="en-GB" sz="1600" dirty="0"/>
              <a:t>Figure S8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3-fold augmentation. </a:t>
            </a:r>
          </a:p>
          <a:p>
            <a:pPr marL="0" indent="0">
              <a:buNone/>
            </a:pPr>
            <a:r>
              <a:rPr lang="en-GB" sz="1600" dirty="0"/>
              <a:t>Figure S9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5-fold augmentation. </a:t>
            </a:r>
          </a:p>
          <a:p>
            <a:pPr marL="0" indent="0">
              <a:buNone/>
            </a:pPr>
            <a:r>
              <a:rPr lang="en-GB" sz="1600" dirty="0"/>
              <a:t>Figure S</a:t>
            </a:r>
            <a:r>
              <a:rPr lang="de-DE" sz="1600" dirty="0"/>
              <a:t>10: </a:t>
            </a:r>
            <a:r>
              <a:rPr lang="en-GB" sz="1600" dirty="0"/>
              <a:t>Figure with confidence intervals for F1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5-fold augmentation. </a:t>
            </a:r>
          </a:p>
          <a:p>
            <a:pPr marL="0" indent="0">
              <a:buNone/>
            </a:pP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17057514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6: Figure with confidence intervals for F1 score for </a:t>
            </a:r>
            <a:r>
              <a:rPr lang="en-GB" sz="2000" u="sng" dirty="0"/>
              <a:t>RNA-</a:t>
            </a:r>
            <a:r>
              <a:rPr lang="en-GB" sz="2000" u="sng" dirty="0" err="1"/>
              <a:t>Seq</a:t>
            </a:r>
            <a:r>
              <a:rPr lang="en-GB" sz="2000" u="sng" dirty="0"/>
              <a:t>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 using only a </a:t>
            </a:r>
            <a:r>
              <a:rPr lang="en-GB" sz="2000" u="sng" dirty="0"/>
              <a:t>small subset</a:t>
            </a:r>
            <a:r>
              <a:rPr lang="en-GB" sz="2000" dirty="0"/>
              <a:t> (30 samples) of the original data for training. 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55445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200" y="1080000"/>
            <a:ext cx="10515600" cy="512322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600" b="1" dirty="0"/>
              <a:t>Microarray / small training set / ANN</a:t>
            </a:r>
          </a:p>
          <a:p>
            <a:pPr marL="0" indent="0">
              <a:buNone/>
            </a:pPr>
            <a:r>
              <a:rPr lang="en-GB" sz="1600" dirty="0"/>
              <a:t>Figure S11: Figure with confidence intervals for accuracy and Brier score for microarray experiment comparing the ANN classification performances of the different augmentation methods after 2-fold augmentation using only a small subset (30 samples) of the original data for training. </a:t>
            </a:r>
          </a:p>
          <a:p>
            <a:pPr marL="0" indent="0">
              <a:buNone/>
            </a:pPr>
            <a:r>
              <a:rPr lang="en-GB" sz="1600" dirty="0"/>
              <a:t>Figure S12: Figure with confidence intervals for accuracy and Brier score for microarray experiment comparing the ANN classification performances of the different augmentation methods after 5-fold augmentation using only a small subset (30 samples) of the original data for training. </a:t>
            </a:r>
          </a:p>
          <a:p>
            <a:pPr marL="0" indent="0">
              <a:buNone/>
            </a:pPr>
            <a:r>
              <a:rPr lang="en-GB" sz="1600" dirty="0"/>
              <a:t>Figure S</a:t>
            </a:r>
            <a:r>
              <a:rPr lang="de-DE" sz="1600" dirty="0"/>
              <a:t>13: </a:t>
            </a:r>
            <a:r>
              <a:rPr lang="en-GB" sz="1600" dirty="0"/>
              <a:t>Figure with confidence intervals for F1 score for microarray experiment comparing the ANN classification performances of the different augmentation methods after 5-fold augmentation using only a small subset (30 samples) of the original data for training. </a:t>
            </a:r>
            <a:endParaRPr lang="de-DE" sz="1600" dirty="0"/>
          </a:p>
          <a:p>
            <a:pPr marL="0" indent="0">
              <a:buNone/>
            </a:pPr>
            <a:endParaRPr lang="en-GB" sz="1600" dirty="0"/>
          </a:p>
        </p:txBody>
      </p:sp>
      <p:sp>
        <p:nvSpPr>
          <p:cNvPr id="5" name="Titel 1"/>
          <p:cNvSpPr>
            <a:spLocks noGrp="1"/>
          </p:cNvSpPr>
          <p:nvPr>
            <p:ph type="title"/>
          </p:nvPr>
        </p:nvSpPr>
        <p:spPr>
          <a:xfrm>
            <a:off x="838200" y="391247"/>
            <a:ext cx="10515600" cy="523149"/>
          </a:xfrm>
        </p:spPr>
        <p:txBody>
          <a:bodyPr>
            <a:normAutofit/>
          </a:bodyPr>
          <a:lstStyle/>
          <a:p>
            <a:r>
              <a:rPr lang="de-DE" sz="2500" b="1" dirty="0">
                <a:latin typeface="+mn-lt"/>
              </a:rPr>
              <a:t>Contents</a:t>
            </a:r>
            <a:endParaRPr lang="en-GB" sz="25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482324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200" y="1080000"/>
            <a:ext cx="10515600" cy="512322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600" b="1" dirty="0"/>
              <a:t>RNA-</a:t>
            </a:r>
            <a:r>
              <a:rPr lang="en-GB" sz="1600" b="1" dirty="0" err="1"/>
              <a:t>Seq</a:t>
            </a:r>
            <a:r>
              <a:rPr lang="en-GB" sz="1600" b="1" dirty="0"/>
              <a:t> / small training set / ANN</a:t>
            </a:r>
          </a:p>
          <a:p>
            <a:pPr marL="0" indent="0">
              <a:buNone/>
            </a:pPr>
            <a:r>
              <a:rPr lang="en-GB" sz="1600" dirty="0"/>
              <a:t>Figure S14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2-fold augmentation using only a small subset (30 samples) of the original data for training. </a:t>
            </a:r>
          </a:p>
          <a:p>
            <a:pPr marL="0" indent="0">
              <a:buNone/>
            </a:pPr>
            <a:r>
              <a:rPr lang="en-GB" sz="1600" dirty="0"/>
              <a:t>Figure S15: Figure with confidence intervals for accuracy and Brier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5-fold augmentation using only a small subset (30 samples) of the original data for training. </a:t>
            </a:r>
          </a:p>
          <a:p>
            <a:pPr marL="0" indent="0">
              <a:buNone/>
            </a:pPr>
            <a:r>
              <a:rPr lang="en-GB" sz="1600" dirty="0"/>
              <a:t>Figure S16: Figure with confidence intervals for F1 score for RNA-</a:t>
            </a:r>
            <a:r>
              <a:rPr lang="en-GB" sz="1600" dirty="0" err="1"/>
              <a:t>Seq</a:t>
            </a:r>
            <a:r>
              <a:rPr lang="en-GB" sz="1600" dirty="0"/>
              <a:t> experiment comparing the ANN classification performances of the different augmentation methods after 5-fold augmentation using only a small subset (30 samples) of the original data for training. </a:t>
            </a:r>
          </a:p>
          <a:p>
            <a:pPr marL="0" indent="0">
              <a:buNone/>
            </a:pPr>
            <a:endParaRPr lang="de-DE" sz="1600" dirty="0"/>
          </a:p>
          <a:p>
            <a:pPr marL="0" indent="0">
              <a:buNone/>
            </a:pPr>
            <a:endParaRPr lang="en-GB" sz="1600" dirty="0"/>
          </a:p>
        </p:txBody>
      </p:sp>
      <p:sp>
        <p:nvSpPr>
          <p:cNvPr id="5" name="Titel 1"/>
          <p:cNvSpPr>
            <a:spLocks noGrp="1"/>
          </p:cNvSpPr>
          <p:nvPr>
            <p:ph type="title"/>
          </p:nvPr>
        </p:nvSpPr>
        <p:spPr>
          <a:xfrm>
            <a:off x="838200" y="391247"/>
            <a:ext cx="10515600" cy="523149"/>
          </a:xfrm>
        </p:spPr>
        <p:txBody>
          <a:bodyPr>
            <a:normAutofit/>
          </a:bodyPr>
          <a:lstStyle/>
          <a:p>
            <a:r>
              <a:rPr lang="de-DE" sz="2500" b="1" dirty="0">
                <a:latin typeface="+mn-lt"/>
              </a:rPr>
              <a:t>Contents</a:t>
            </a:r>
            <a:endParaRPr lang="en-GB" sz="25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722190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38868" y="205734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1: Figure with confidence intervals for accuracy and Brier score for </a:t>
            </a:r>
            <a:r>
              <a:rPr lang="en-GB" sz="2000" u="sng" dirty="0"/>
              <a:t>microarray experiment </a:t>
            </a:r>
            <a:r>
              <a:rPr lang="en-GB" sz="2000" dirty="0"/>
              <a:t>comparing the ANN classification performances of the different augmentation methods after </a:t>
            </a:r>
            <a:r>
              <a:rPr lang="en-GB" sz="2000" u="sng" dirty="0"/>
              <a:t>1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199" y="1146265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58032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2: Figure with confidence intervals for accuracy and Brier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2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74105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3: Figure with confidence intervals for accuracy and Brier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3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2499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4: Figure with confidence intervals for accuracy and Brier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. T</a:t>
            </a:r>
            <a:r>
              <a:rPr lang="en-US" sz="2000" dirty="0"/>
              <a:t>he details are showed in (A) and (B).</a:t>
            </a:r>
            <a:endParaRPr lang="en-GB" sz="20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42732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3149"/>
          </a:xfrm>
        </p:spPr>
        <p:txBody>
          <a:bodyPr>
            <a:noAutofit/>
          </a:bodyPr>
          <a:lstStyle/>
          <a:p>
            <a:r>
              <a:rPr lang="en-GB" sz="2000" dirty="0"/>
              <a:t>Figure S5: Figure with confidence intervals for F1 score for </a:t>
            </a:r>
            <a:r>
              <a:rPr lang="en-GB" sz="2000" u="sng" dirty="0"/>
              <a:t>microarray experiment</a:t>
            </a:r>
            <a:r>
              <a:rPr lang="en-GB" sz="2000" dirty="0"/>
              <a:t> comparing the ANN classification performances of the different augmentation methods after </a:t>
            </a:r>
            <a:r>
              <a:rPr lang="en-GB" sz="2000" u="sng" dirty="0"/>
              <a:t>5-fold augmentation</a:t>
            </a:r>
            <a:r>
              <a:rPr lang="en-GB" sz="2000" dirty="0"/>
              <a:t>. 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800" y="1144800"/>
            <a:ext cx="90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1958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83</Words>
  <Application>Microsoft Office PowerPoint</Application>
  <PresentationFormat>Widescreen</PresentationFormat>
  <Paragraphs>40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</vt:lpstr>
      <vt:lpstr>Contents</vt:lpstr>
      <vt:lpstr>Contents</vt:lpstr>
      <vt:lpstr>Contents</vt:lpstr>
      <vt:lpstr>Contents</vt:lpstr>
      <vt:lpstr>Figure S1: Figure with confidence intervals for accuracy and Brier score for microarray experiment comparing the ANN classification performances of the different augmentation methods after 1-fold augmentation. The details are showed in (A) and (B).</vt:lpstr>
      <vt:lpstr>Figure S2: Figure with confidence intervals for accuracy and Brier score for microarray experiment comparing the ANN classification performances of the different augmentation methods after 2-fold augmentation. The details are showed in (A) and (B).</vt:lpstr>
      <vt:lpstr>Figure S3: Figure with confidence intervals for accuracy and Brier score for microarray experiment comparing the ANN classification performances of the different augmentation methods after 3-fold augmentation. The details are showed in (A) and (B).</vt:lpstr>
      <vt:lpstr>Figure S4: Figure with confidence intervals for accuracy and Brier score for microarray experiment comparing the ANN classification performances of the different augmentation methods after 5-fold augmentation. The details are showed in (A) and (B).</vt:lpstr>
      <vt:lpstr>Figure S5: Figure with confidence intervals for F1 score for microarray experiment comparing the ANN classification performances of the different augmentation methods after 5-fold augmentation. </vt:lpstr>
      <vt:lpstr>Figure S6: Figure with confidence intervals for accuracy and Brier score for RNA-seq experiment comparing the ANN classification performances of the different augmentation methods after 1-fold augmentation. The details are showed in (A) and (B).</vt:lpstr>
      <vt:lpstr>Figure S7: Figure with confidence intervals for accuracy and Brier score for RNA-Seq experiment comparing the ANN classification performances of the different augmentation methods after 2-fold augmentation. The details are showed in (A) and (B).</vt:lpstr>
      <vt:lpstr>Figure S8: Figure with confidence intervals for accuracy and Brier score for RNA-Seq experiment comparing the ANN classification performances of the different augmentation methods after 3-fold augmentation. The details are showed in (A) and (B).</vt:lpstr>
      <vt:lpstr>Figure S9: Figure with confidence intervals for accuracy and Brier score for RNA-Seq experiment comparing the ANN classification performances of the different augmentation methods after 5-fold augmentation. The details are showed in (A) and (B).</vt:lpstr>
      <vt:lpstr>Figure S10: Figure with confidence intervals for F1 score for RNA-Seq experiment comparing the ANN classification performances of the different augmentation methods after 5-fold augmentation. </vt:lpstr>
      <vt:lpstr>Figure S11: Figure with confidence intervals for accuracy and Brier score for microarray experiment comparing the ANN classification performances of the different augmentation methods after 2-fold augmentation using only a small subset (30 samples) of the original data for training. The details are showed in (A) and (B).</vt:lpstr>
      <vt:lpstr>Figure S12: Figure with confidence intervals for accuracy and Brier score for microarray experiment comparing the ANN classification performances of the different augmentation methods after 5-fold augmentation using only a small subset (30 samples) of the original data for training. The details are showed in (A) and (B).</vt:lpstr>
      <vt:lpstr>Figure S13: Figure with confidence intervals for F1 score for microarray experiment comparing the ANN classification performances of the different augmentation methods after 5-fold augmentation using only a small subset (30 samples) of the original data for training. </vt:lpstr>
      <vt:lpstr>Figure S14: Figure with confidence intervals for accuracy and Brier score for RNA-Seq experiment comparing the ANN classification performances of the different augmentation methods after 2-fold augmentation using only a small subset (30 samples) of the original data for training. The details are showed in (A) and (B).</vt:lpstr>
      <vt:lpstr>Figure S15: Figure with confidence intervals for accuracy and Brier score for RNA-Seq experiment comparing the ANN classification performances of the different augmentation methods after 5-fold augmentation using only a small subset (30 samples) of the original data for training. The details are showed in (A) and (B).</vt:lpstr>
      <vt:lpstr>Figure S16: Figure with confidence intervals for F1 score for RNA-Seq experiment comparing the ANN classification performances of the different augmentation methods after 5-fold augmentation using only a small subset (30 samples) of the original data for training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tents</dc:title>
  <dc:creator>Kircher, Magdalena</dc:creator>
  <cp:lastModifiedBy>MDPI</cp:lastModifiedBy>
  <cp:revision>29</cp:revision>
  <dcterms:created xsi:type="dcterms:W3CDTF">2022-01-31T09:43:51Z</dcterms:created>
  <dcterms:modified xsi:type="dcterms:W3CDTF">2022-02-24T09:39:55Z</dcterms:modified>
</cp:coreProperties>
</file>